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F35E8F9-4C7C-47B4-AF8A-8C008FBD1646}" v="7" dt="2025-08-22T20:33:06.49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7167" autoAdjust="0"/>
  </p:normalViewPr>
  <p:slideViewPr>
    <p:cSldViewPr snapToGrid="0">
      <p:cViewPr varScale="1">
        <p:scale>
          <a:sx n="96" d="100"/>
          <a:sy n="96" d="100"/>
        </p:scale>
        <p:origin x="115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lauer, Jacob" userId="47b91e25-752e-41d6-afa2-ac919e9eae0a" providerId="ADAL" clId="{7F35E8F9-4C7C-47B4-AF8A-8C008FBD1646}"/>
    <pc:docChg chg="modSld">
      <pc:chgData name="Blauer, Jacob" userId="47b91e25-752e-41d6-afa2-ac919e9eae0a" providerId="ADAL" clId="{7F35E8F9-4C7C-47B4-AF8A-8C008FBD1646}" dt="2025-09-04T16:05:38.786" v="553" actId="20577"/>
      <pc:docMkLst>
        <pc:docMk/>
      </pc:docMkLst>
      <pc:sldChg chg="addSp modSp mod modNotesTx">
        <pc:chgData name="Blauer, Jacob" userId="47b91e25-752e-41d6-afa2-ac919e9eae0a" providerId="ADAL" clId="{7F35E8F9-4C7C-47B4-AF8A-8C008FBD1646}" dt="2025-09-04T16:05:38.786" v="553" actId="20577"/>
        <pc:sldMkLst>
          <pc:docMk/>
          <pc:sldMk cId="2618974465" sldId="256"/>
        </pc:sldMkLst>
        <pc:spChg chg="add mod">
          <ac:chgData name="Blauer, Jacob" userId="47b91e25-752e-41d6-afa2-ac919e9eae0a" providerId="ADAL" clId="{7F35E8F9-4C7C-47B4-AF8A-8C008FBD1646}" dt="2025-08-22T20:32:07.130" v="480" actId="1035"/>
          <ac:spMkLst>
            <pc:docMk/>
            <pc:sldMk cId="2618974465" sldId="256"/>
            <ac:spMk id="5" creationId="{BC24AFD2-2F11-2DCF-5EFF-D003A3BD857C}"/>
          </ac:spMkLst>
        </pc:spChg>
        <pc:spChg chg="add mod">
          <ac:chgData name="Blauer, Jacob" userId="47b91e25-752e-41d6-afa2-ac919e9eae0a" providerId="ADAL" clId="{7F35E8F9-4C7C-47B4-AF8A-8C008FBD1646}" dt="2025-08-22T20:32:58.990" v="545" actId="1036"/>
          <ac:spMkLst>
            <pc:docMk/>
            <pc:sldMk cId="2618974465" sldId="256"/>
            <ac:spMk id="7" creationId="{B568F38E-E678-6FBB-93C6-FFF8EB33F469}"/>
          </ac:spMkLst>
        </pc:spChg>
        <pc:spChg chg="add mod">
          <ac:chgData name="Blauer, Jacob" userId="47b91e25-752e-41d6-afa2-ac919e9eae0a" providerId="ADAL" clId="{7F35E8F9-4C7C-47B4-AF8A-8C008FBD1646}" dt="2025-08-22T20:32:43.888" v="509" actId="1036"/>
          <ac:spMkLst>
            <pc:docMk/>
            <pc:sldMk cId="2618974465" sldId="256"/>
            <ac:spMk id="9" creationId="{71211A23-A990-16A5-8D39-F0C5AAA303FE}"/>
          </ac:spMkLst>
        </pc:spChg>
        <pc:spChg chg="add mod">
          <ac:chgData name="Blauer, Jacob" userId="47b91e25-752e-41d6-afa2-ac919e9eae0a" providerId="ADAL" clId="{7F35E8F9-4C7C-47B4-AF8A-8C008FBD1646}" dt="2025-09-04T16:05:32.450" v="552" actId="20577"/>
          <ac:spMkLst>
            <pc:docMk/>
            <pc:sldMk cId="2618974465" sldId="256"/>
            <ac:spMk id="10" creationId="{3097D20E-4F54-801C-43F1-00EEAAF33CEC}"/>
          </ac:spMkLst>
        </pc:spChg>
        <pc:picChg chg="add mod">
          <ac:chgData name="Blauer, Jacob" userId="47b91e25-752e-41d6-afa2-ac919e9eae0a" providerId="ADAL" clId="{7F35E8F9-4C7C-47B4-AF8A-8C008FBD1646}" dt="2025-08-22T20:32:35.723" v="491" actId="1036"/>
          <ac:picMkLst>
            <pc:docMk/>
            <pc:sldMk cId="2618974465" sldId="256"/>
            <ac:picMk id="4" creationId="{2448D348-4635-C28C-29D6-C75DA90FB09D}"/>
          </ac:picMkLst>
        </pc:picChg>
        <pc:picChg chg="add mod">
          <ac:chgData name="Blauer, Jacob" userId="47b91e25-752e-41d6-afa2-ac919e9eae0a" providerId="ADAL" clId="{7F35E8F9-4C7C-47B4-AF8A-8C008FBD1646}" dt="2025-08-22T20:32:52.255" v="532" actId="1037"/>
          <ac:picMkLst>
            <pc:docMk/>
            <pc:sldMk cId="2618974465" sldId="256"/>
            <ac:picMk id="6" creationId="{CC998AA0-2614-4025-BBE8-938B6DF17D1E}"/>
          </ac:picMkLst>
        </pc:picChg>
        <pc:picChg chg="add mod">
          <ac:chgData name="Blauer, Jacob" userId="47b91e25-752e-41d6-afa2-ac919e9eae0a" providerId="ADAL" clId="{7F35E8F9-4C7C-47B4-AF8A-8C008FBD1646}" dt="2025-08-22T20:32:39.143" v="498" actId="1035"/>
          <ac:picMkLst>
            <pc:docMk/>
            <pc:sldMk cId="2618974465" sldId="256"/>
            <ac:picMk id="8" creationId="{7F3649AC-9A06-480D-A050-9F060EF7B6B6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102D6B-83B4-42E0-A061-B654AC86AD91}" type="datetimeFigureOut">
              <a:rPr lang="en-US" smtClean="0"/>
              <a:t>9/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21EBC9C-FE6B-46C9-9378-5152E15403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9926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</a:t>
            </a:r>
            <a:r>
              <a:rPr lang="en-US"/>
              <a:t>Figure S1</a:t>
            </a:r>
            <a:r>
              <a:rPr lang="en-US" dirty="0"/>
              <a:t>. Photos of tubers from hand-digs at 132 days after planting for each cultivar. A) cultivar Alturas. B) cultivar Russet Burbank. C) cultivar Clearwater Russet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21EBC9C-FE6B-46C9-9378-5152E15403A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1034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25FD1D-E100-BF2A-2A50-D22CA65B2D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670E95A-01F4-C5DF-EEC0-C094825D37B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66A499-FB33-6820-4E6F-BF49E534CA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E364D-D8A4-4458-B07E-A85E2551A8EF}" type="datetimeFigureOut">
              <a:rPr lang="en-US" smtClean="0"/>
              <a:t>9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439C23-7AF9-F78C-2D37-EEC8317271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BB30BE-6410-5626-F357-C309252F8B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B9A4E-58B7-47CE-BCD2-A63D0F6C3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8710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1F9C01-C85C-298B-76B0-ADE3F882F8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890FCB7-37D5-A26A-6534-4F6866CD98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82D730-892C-26BB-0F46-CD44DF1B85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E364D-D8A4-4458-B07E-A85E2551A8EF}" type="datetimeFigureOut">
              <a:rPr lang="en-US" smtClean="0"/>
              <a:t>9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733227-23EF-E4EE-6E5A-27F8722FB9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A24A78-4FD1-3E27-29C6-9C27171E0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B9A4E-58B7-47CE-BCD2-A63D0F6C3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9247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9666791-86D2-01B8-788E-F670D35D8F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5EA411-71AE-0D24-4441-C68E6234A6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14F9A4-FE7C-F654-3A76-FB0A957B20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E364D-D8A4-4458-B07E-A85E2551A8EF}" type="datetimeFigureOut">
              <a:rPr lang="en-US" smtClean="0"/>
              <a:t>9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EBA090-1380-6BE1-F134-8D50F3C960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E9E205-1F39-3150-E1BE-5C89EDF119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B9A4E-58B7-47CE-BCD2-A63D0F6C3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5255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584777-BEAC-AD54-93C1-C096F1CBAB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54479A-C321-3E08-428D-B7B2952A94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34EFA5-6FAF-737F-C58C-8D7F042FDB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E364D-D8A4-4458-B07E-A85E2551A8EF}" type="datetimeFigureOut">
              <a:rPr lang="en-US" smtClean="0"/>
              <a:t>9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1E12B9-3EA5-69D6-3E09-9ECA375A90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7AE65E-A134-C587-CFA9-73EDD4D137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B9A4E-58B7-47CE-BCD2-A63D0F6C3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322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A420EE-F96A-D373-B4BE-7A5FF8147F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044296-FA9B-ED95-B6FB-A379342FAD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8AFE89-44F8-6F82-6E5C-C9ECBCD98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E364D-D8A4-4458-B07E-A85E2551A8EF}" type="datetimeFigureOut">
              <a:rPr lang="en-US" smtClean="0"/>
              <a:t>9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615FE1-5D51-768C-4EB9-85C939D567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B94934-B348-E542-8330-11FAD26A4E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B9A4E-58B7-47CE-BCD2-A63D0F6C3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6227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DAACAB-6541-F131-F66C-F67AD79CD5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BE2792-3ED2-3558-BA8F-F916B1054DC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D81E960-184D-AF92-88B8-5668DF807B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49F33E-C347-9591-BE3B-91032157C7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E364D-D8A4-4458-B07E-A85E2551A8EF}" type="datetimeFigureOut">
              <a:rPr lang="en-US" smtClean="0"/>
              <a:t>9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A70478-077F-ACDB-9ED9-A6F5BEFA02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F8438F-A9B6-CCA5-C50A-9B149DE207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B9A4E-58B7-47CE-BCD2-A63D0F6C3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8539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CD97E5-F48A-6AEF-4981-6A6B824E24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F4972F-7B5E-6DE3-1B16-907B94F523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FB8116B-7F99-8DCB-72A3-7CD44379D5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9333F61-2032-1EBE-665F-A2DFB4F0C45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5970B87-C6BF-630B-DDEB-230637DB8B8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FC507FD-90E8-614C-B0A3-AF62E18A56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E364D-D8A4-4458-B07E-A85E2551A8EF}" type="datetimeFigureOut">
              <a:rPr lang="en-US" smtClean="0"/>
              <a:t>9/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58DC4FF-0113-C52C-BD6F-C9EB9A5E6F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E26F6A5-B710-890D-A716-F7ECB60D05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B9A4E-58B7-47CE-BCD2-A63D0F6C3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7445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51D399-4382-79C4-6849-2D00C67A8F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0B6CCB8-25E3-0813-6C38-AEE2595AAC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E364D-D8A4-4458-B07E-A85E2551A8EF}" type="datetimeFigureOut">
              <a:rPr lang="en-US" smtClean="0"/>
              <a:t>9/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33B884-78C9-EE50-4540-70A3586AB5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099D1B7-BB52-FDA3-67CE-07B15CA786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B9A4E-58B7-47CE-BCD2-A63D0F6C3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9204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79D229A-1021-E995-7C2D-2336529B17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E364D-D8A4-4458-B07E-A85E2551A8EF}" type="datetimeFigureOut">
              <a:rPr lang="en-US" smtClean="0"/>
              <a:t>9/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3C554BF-AC2A-3D3C-0805-438AB710E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8B2A644-3AE6-E34F-622B-AC63D8998E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B9A4E-58B7-47CE-BCD2-A63D0F6C3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07814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B6AAD2-A241-78FA-4DC9-9798A81D69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43E44E-7454-139C-74C0-28F262CE9B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3D68000-BD50-46BD-557C-267B0BF175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49BC1C-6404-4971-8E7E-85B5B0713D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E364D-D8A4-4458-B07E-A85E2551A8EF}" type="datetimeFigureOut">
              <a:rPr lang="en-US" smtClean="0"/>
              <a:t>9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2986BA-3668-82A9-4803-9929863CCB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CA2FDA-B56E-D677-D7AD-00AACB073B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B9A4E-58B7-47CE-BCD2-A63D0F6C3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85290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94EEE2-64D6-83BE-D16C-515B67EE84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1540842-8BCA-12A6-CE51-95DC4DDBD7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4A2301-39AE-9C03-407B-A1C3DE2F97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B1ABE4-0DDA-F1DF-1E5E-233EA4C384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E364D-D8A4-4458-B07E-A85E2551A8EF}" type="datetimeFigureOut">
              <a:rPr lang="en-US" smtClean="0"/>
              <a:t>9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81D54C-5BAD-7D44-6AC3-73D76CA91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24EC9E-D23E-BF3D-A7D4-691FB2F744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B9A4E-58B7-47CE-BCD2-A63D0F6C3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8567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AEE5556-0950-9079-1106-BA88CB6B6E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F56DB1-C0CA-C7AD-0829-338CE85B8D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C41ACC-FD2D-3047-8F18-60BEB7E6A4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4E364D-D8A4-4458-B07E-A85E2551A8EF}" type="datetimeFigureOut">
              <a:rPr lang="en-US" smtClean="0"/>
              <a:t>9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38E5F8-C414-9CC8-C87D-DFD3102E68B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76EC94-048A-FB23-D38F-FE6547F22B2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9B9A4E-58B7-47CE-BCD2-A63D0F6C3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925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448D348-4635-C28C-29D6-C75DA90FB0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6967" y="75923"/>
            <a:ext cx="4400101" cy="329714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C24AFD2-2F11-2DCF-5EFF-D003A3BD857C}"/>
              </a:ext>
            </a:extLst>
          </p:cNvPr>
          <p:cNvSpPr txBox="1"/>
          <p:nvPr/>
        </p:nvSpPr>
        <p:spPr>
          <a:xfrm>
            <a:off x="1063487" y="119275"/>
            <a:ext cx="4043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FF00"/>
                </a:solidFill>
              </a:rPr>
              <a:t>A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C998AA0-2614-4025-BBE8-938B6DF17D1E}"/>
              </a:ext>
              <a:ext uri="{147F2762-F138-4A5C-976F-8EAC2B608ADB}">
                <a16:predDERef xmlns:a16="http://schemas.microsoft.com/office/drawing/2014/main" pred="{4BAF270A-0E74-4B70-9D42-9E332653630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09596" y="83111"/>
            <a:ext cx="4399720" cy="329979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568F38E-E678-6FBB-93C6-FFF8EB33F469}"/>
              </a:ext>
            </a:extLst>
          </p:cNvPr>
          <p:cNvSpPr txBox="1"/>
          <p:nvPr/>
        </p:nvSpPr>
        <p:spPr>
          <a:xfrm>
            <a:off x="5579160" y="102712"/>
            <a:ext cx="4043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FF00"/>
                </a:solidFill>
              </a:rPr>
              <a:t>B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7F3649AC-9A06-480D-A050-9F060EF7B6B6}"/>
              </a:ext>
              <a:ext uri="{147F2762-F138-4A5C-976F-8EAC2B608ADB}">
                <a16:predDERef xmlns:a16="http://schemas.microsoft.com/office/drawing/2014/main" pred="{CC998AA0-2614-4025-BBE8-938B6DF17D1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06967" y="3456073"/>
            <a:ext cx="4399720" cy="329979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71211A23-A990-16A5-8D39-F0C5AAA303FE}"/>
              </a:ext>
            </a:extLst>
          </p:cNvPr>
          <p:cNvSpPr txBox="1"/>
          <p:nvPr/>
        </p:nvSpPr>
        <p:spPr>
          <a:xfrm>
            <a:off x="1066802" y="3482011"/>
            <a:ext cx="4043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FF00"/>
                </a:solidFill>
              </a:rPr>
              <a:t>C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097D20E-4F54-801C-43F1-00EEAAF33CEC}"/>
              </a:ext>
            </a:extLst>
          </p:cNvPr>
          <p:cNvSpPr txBox="1"/>
          <p:nvPr/>
        </p:nvSpPr>
        <p:spPr>
          <a:xfrm>
            <a:off x="5579160" y="3482011"/>
            <a:ext cx="439972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1. Photos of tubers from hand-digs at 132 days after planting for each cultivar. A) cultivar Alturas. B) cultivar Russet Burbank. C) cultivar Clearwater Russet.</a:t>
            </a:r>
          </a:p>
        </p:txBody>
      </p:sp>
    </p:spTree>
    <p:extLst>
      <p:ext uri="{BB962C8B-B14F-4D97-AF65-F5344CB8AC3E}">
        <p14:creationId xmlns:p14="http://schemas.microsoft.com/office/powerpoint/2010/main" val="26189744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</TotalTime>
  <Words>77</Words>
  <Application>Microsoft Office PowerPoint</Application>
  <PresentationFormat>Widescreen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lauer, Jacob</dc:creator>
  <cp:lastModifiedBy>Blauer, Jacob</cp:lastModifiedBy>
  <cp:revision>1</cp:revision>
  <dcterms:created xsi:type="dcterms:W3CDTF">2025-08-22T20:25:23Z</dcterms:created>
  <dcterms:modified xsi:type="dcterms:W3CDTF">2025-09-04T16:05:41Z</dcterms:modified>
</cp:coreProperties>
</file>